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097EB-FF64-44D4-BC4F-6BFEE8C86A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23FB8-A1C3-40E3-AECD-2088EF5EB4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511C5-CC18-45F4-8539-A698596C80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A745E-02CD-4264-862C-1D21F50824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85428-C639-4B54-B875-265C3D17B0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B6CD3-BBE0-4A95-AF1C-D6999DA134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F0A4A-7036-40F3-AF5F-18286B62F0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D6951-5FFF-44A5-B20C-F7B5396845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F8ADF-826B-4BC2-A5FB-698CFEB03E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6EB600-7E1A-4459-A1CF-67ED6C67D3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FF064-26DC-4375-B751-B8F980EA6D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E98DB-D6DC-4BBF-A70E-CADF3FE2A5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F52538-CCCB-4A30-B278-98A5F26EC09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rcRect l="0" t="0" r="11682" b="0"/>
          <a:stretch/>
        </p:blipFill>
        <p:spPr>
          <a:xfrm>
            <a:off x="971640" y="1414440"/>
            <a:ext cx="7345440" cy="544356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5"/>
          <p:cNvSpPr/>
          <p:nvPr/>
        </p:nvSpPr>
        <p:spPr>
          <a:xfrm>
            <a:off x="684360" y="404280"/>
            <a:ext cx="7488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CDS sequence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D37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 Arrows indicate the point mutation (C to A) in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SD37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DNA sequence. Sequence comparison revealed an amino acid substitution of T to K in SD37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12T13:18:49Z</dcterms:created>
  <dc:creator>Windows 用户</dc:creator>
  <dc:description/>
  <dc:language>en-US</dc:language>
  <cp:lastModifiedBy>Lenovo User</cp:lastModifiedBy>
  <dcterms:modified xsi:type="dcterms:W3CDTF">2013-11-22T08:08:27Z</dcterms:modified>
  <cp:revision>8</cp:revision>
  <dc:subject/>
  <dc:title>幻灯片 1</dc:title>
</cp:coreProperties>
</file>